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13716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86000" y="685440"/>
            <a:ext cx="2286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56A068C-FACE-4058-8DE4-F85C811F1BB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PlaceHolder 1"/>
          <p:cNvSpPr>
            <a:spLocks noGrp="1"/>
          </p:cNvSpPr>
          <p:nvPr>
            <p:ph type="sldImg"/>
          </p:nvPr>
        </p:nvSpPr>
        <p:spPr>
          <a:xfrm>
            <a:off x="2286000" y="685800"/>
            <a:ext cx="2286000" cy="3429000"/>
          </a:xfrm>
          <a:prstGeom prst="rect">
            <a:avLst/>
          </a:prstGeom>
          <a:ln w="0">
            <a:noFill/>
          </a:ln>
        </p:spPr>
      </p:sp>
      <p:sp>
        <p:nvSpPr>
          <p:cNvPr id="7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B05E2C7-83F5-4DC7-823C-50A551C94B66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BD311C-1A67-4196-8854-1D6EDB8B10D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549360"/>
            <a:ext cx="8229600" cy="228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3200400"/>
            <a:ext cx="8229600" cy="431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7928280"/>
            <a:ext cx="8229600" cy="431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87BDDA-689B-4CB9-985D-8E7A36A579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549360"/>
            <a:ext cx="8229600" cy="228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3200400"/>
            <a:ext cx="4015800" cy="431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3200400"/>
            <a:ext cx="4015800" cy="431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7928280"/>
            <a:ext cx="4015800" cy="431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7928280"/>
            <a:ext cx="4015800" cy="431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291795-F1F6-4472-9BD0-844A2284DBD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549360"/>
            <a:ext cx="8229600" cy="228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3200400"/>
            <a:ext cx="2649600" cy="431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3200400"/>
            <a:ext cx="2649600" cy="431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3200400"/>
            <a:ext cx="2649600" cy="431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7928280"/>
            <a:ext cx="2649600" cy="431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7928280"/>
            <a:ext cx="2649600" cy="431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7928280"/>
            <a:ext cx="2649600" cy="431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8A97CB-7477-468E-A153-EF1BABF1E39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549360"/>
            <a:ext cx="8229600" cy="228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3200400"/>
            <a:ext cx="8229600" cy="9051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3EF794-A18E-471E-9698-6D90DE2884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549360"/>
            <a:ext cx="8229600" cy="228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3200400"/>
            <a:ext cx="8229600" cy="9051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7353A2-BFB8-4CF6-8DFE-CDC89C00CD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549360"/>
            <a:ext cx="8229600" cy="228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3200400"/>
            <a:ext cx="4015800" cy="9051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3200400"/>
            <a:ext cx="4015800" cy="9051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FC0503-8034-46CA-9AC3-A0BFC3D34FE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549360"/>
            <a:ext cx="8229600" cy="228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CD7AB3-9D74-41B1-9CFB-89950B87EA5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549360"/>
            <a:ext cx="8229600" cy="10597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F18EC9-E6B9-454E-8F35-35CD2E73E2B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549360"/>
            <a:ext cx="8229600" cy="228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3200400"/>
            <a:ext cx="4015800" cy="431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3200400"/>
            <a:ext cx="4015800" cy="9051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7928280"/>
            <a:ext cx="4015800" cy="431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A2F3D6-1776-4CD3-8AEC-9E096A45E8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549360"/>
            <a:ext cx="8229600" cy="228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3200400"/>
            <a:ext cx="4015800" cy="9051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3200400"/>
            <a:ext cx="4015800" cy="431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7928280"/>
            <a:ext cx="4015800" cy="431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16FB6B-EA0F-43B9-A1C3-3EED2F0B89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549360"/>
            <a:ext cx="8229600" cy="228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3200400"/>
            <a:ext cx="4015800" cy="431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3200400"/>
            <a:ext cx="4015800" cy="431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7928280"/>
            <a:ext cx="8229600" cy="431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125116-0E3F-4C6C-B77E-466FD867E7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549360"/>
            <a:ext cx="8229600" cy="228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3200400"/>
            <a:ext cx="8229600" cy="9051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12712320"/>
            <a:ext cx="2133720" cy="73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12712320"/>
            <a:ext cx="2895840" cy="73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12712320"/>
            <a:ext cx="2133720" cy="73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ACAEC1A-85DC-4065-8DAE-FF96A3C1BF0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"/>
          <p:cNvPicPr/>
          <p:nvPr/>
        </p:nvPicPr>
        <p:blipFill>
          <a:blip r:embed="rId1"/>
          <a:srcRect l="19533" t="13543" r="2344" b="6250"/>
          <a:stretch/>
        </p:blipFill>
        <p:spPr>
          <a:xfrm>
            <a:off x="533520" y="914400"/>
            <a:ext cx="7619760" cy="5867280"/>
          </a:xfrm>
          <a:prstGeom prst="rect">
            <a:avLst/>
          </a:prstGeom>
          <a:ln w="0">
            <a:noFill/>
          </a:ln>
        </p:spPr>
      </p:pic>
      <p:sp>
        <p:nvSpPr>
          <p:cNvPr id="49" name="TextBox 4"/>
          <p:cNvSpPr/>
          <p:nvPr/>
        </p:nvSpPr>
        <p:spPr>
          <a:xfrm>
            <a:off x="457200" y="304920"/>
            <a:ext cx="8686800" cy="703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Additional File 1.  </a:t>
            </a:r>
            <a:r>
              <a:rPr b="0" i="1" lang="en-US" sz="2000" spc="-1" strike="noStrike">
                <a:solidFill>
                  <a:srgbClr val="000000"/>
                </a:solidFill>
                <a:latin typeface="Calibri"/>
              </a:rPr>
              <a:t>T. cruzi </a:t>
            </a: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chromosome 35.  ECH 1</a:t>
            </a:r>
            <a:r>
              <a:rPr b="0" lang="en-US" sz="2000" spc="-1" strike="noStrike" baseline="30000">
                <a:solidFill>
                  <a:srgbClr val="000000"/>
                </a:solidFill>
                <a:latin typeface="Calibri"/>
              </a:rPr>
              <a:t>(-/+) </a:t>
            </a: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,ECH 2</a:t>
            </a:r>
            <a:r>
              <a:rPr b="0" lang="en-US" sz="2000" spc="-1" strike="noStrike" baseline="30000">
                <a:solidFill>
                  <a:srgbClr val="000000"/>
                </a:solidFill>
                <a:latin typeface="Calibri"/>
              </a:rPr>
              <a:t>(-/+) </a:t>
            </a: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vs wild type.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A. Whole chromosome view.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0" name="Straight Arrow Connector 5"/>
          <p:cNvCxnSpPr/>
          <p:nvPr/>
        </p:nvCxnSpPr>
        <p:spPr>
          <a:xfrm flipH="1">
            <a:off x="2209320" y="1828800"/>
            <a:ext cx="2743920" cy="838800"/>
          </a:xfrm>
          <a:prstGeom prst="straightConnector1">
            <a:avLst/>
          </a:prstGeom>
          <a:ln w="25560">
            <a:solidFill>
              <a:srgbClr val="ff0000"/>
            </a:solidFill>
            <a:miter/>
            <a:tailEnd len="med" type="arrow" w="med"/>
          </a:ln>
        </p:spPr>
      </p:cxnSp>
      <p:sp>
        <p:nvSpPr>
          <p:cNvPr id="51" name="TextBox 6"/>
          <p:cNvSpPr/>
          <p:nvPr/>
        </p:nvSpPr>
        <p:spPr>
          <a:xfrm>
            <a:off x="4572000" y="1382760"/>
            <a:ext cx="4648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ECH 1, ECH 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2" name="Picture 2" descr=""/>
          <p:cNvPicPr/>
          <p:nvPr/>
        </p:nvPicPr>
        <p:blipFill>
          <a:blip r:embed="rId2"/>
          <a:srcRect l="0" t="68130" r="6249" b="25000"/>
          <a:stretch/>
        </p:blipFill>
        <p:spPr>
          <a:xfrm>
            <a:off x="1447920" y="5908680"/>
            <a:ext cx="6400800" cy="352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3" name="Oval 8"/>
          <p:cNvSpPr/>
          <p:nvPr/>
        </p:nvSpPr>
        <p:spPr>
          <a:xfrm>
            <a:off x="5715000" y="5791320"/>
            <a:ext cx="609480" cy="685800"/>
          </a:xfrm>
          <a:prstGeom prst="ellipse">
            <a:avLst/>
          </a:prstGeom>
          <a:noFill/>
          <a:ln w="25560">
            <a:solidFill>
              <a:srgbClr val="66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4" name="Straight Arrow Connector 9"/>
          <p:cNvCxnSpPr/>
          <p:nvPr/>
        </p:nvCxnSpPr>
        <p:spPr>
          <a:xfrm>
            <a:off x="5256720" y="1828440"/>
            <a:ext cx="762840" cy="3886920"/>
          </a:xfrm>
          <a:prstGeom prst="straightConnector1">
            <a:avLst/>
          </a:prstGeom>
          <a:ln w="25560">
            <a:solidFill>
              <a:srgbClr val="ff0000"/>
            </a:solidFill>
            <a:miter/>
            <a:tailEnd len="med" type="arrow" w="med"/>
          </a:ln>
        </p:spPr>
      </p:cxnSp>
      <p:sp>
        <p:nvSpPr>
          <p:cNvPr id="55" name="Straight Connector 15"/>
          <p:cNvSpPr/>
          <p:nvPr/>
        </p:nvSpPr>
        <p:spPr>
          <a:xfrm>
            <a:off x="1905120" y="6400800"/>
            <a:ext cx="0" cy="7632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Straight Connector 16"/>
          <p:cNvSpPr/>
          <p:nvPr/>
        </p:nvSpPr>
        <p:spPr>
          <a:xfrm>
            <a:off x="2209680" y="6400800"/>
            <a:ext cx="0" cy="7632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Straight Connector 17"/>
          <p:cNvSpPr/>
          <p:nvPr/>
        </p:nvSpPr>
        <p:spPr>
          <a:xfrm flipH="1">
            <a:off x="1447920" y="5637960"/>
            <a:ext cx="457200" cy="228600"/>
          </a:xfrm>
          <a:prstGeom prst="line">
            <a:avLst/>
          </a:prstGeom>
          <a:ln w="25560">
            <a:solidFill>
              <a:srgbClr val="ff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Straight Connector 18"/>
          <p:cNvSpPr/>
          <p:nvPr/>
        </p:nvSpPr>
        <p:spPr>
          <a:xfrm flipH="1" flipV="1">
            <a:off x="2286000" y="5638320"/>
            <a:ext cx="5486400" cy="228600"/>
          </a:xfrm>
          <a:prstGeom prst="line">
            <a:avLst/>
          </a:prstGeom>
          <a:ln w="25560">
            <a:solidFill>
              <a:srgbClr val="ff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9" name="Picture 2" descr=""/>
          <p:cNvPicPr/>
          <p:nvPr/>
        </p:nvPicPr>
        <p:blipFill>
          <a:blip r:embed="rId3"/>
          <a:srcRect l="19533" t="13750" r="4688" b="4749"/>
          <a:stretch/>
        </p:blipFill>
        <p:spPr>
          <a:xfrm>
            <a:off x="533520" y="7448400"/>
            <a:ext cx="7391160" cy="5962680"/>
          </a:xfrm>
          <a:prstGeom prst="rect">
            <a:avLst/>
          </a:prstGeom>
          <a:ln w="0">
            <a:noFill/>
          </a:ln>
        </p:spPr>
      </p:pic>
      <p:cxnSp>
        <p:nvCxnSpPr>
          <p:cNvPr id="60" name="Straight Arrow Connector 20"/>
          <p:cNvCxnSpPr/>
          <p:nvPr/>
        </p:nvCxnSpPr>
        <p:spPr>
          <a:xfrm flipV="1">
            <a:off x="8150760" y="3934800"/>
            <a:ext cx="3960" cy="99108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61" name="Straight Arrow Connector 21"/>
          <p:cNvCxnSpPr/>
          <p:nvPr/>
        </p:nvCxnSpPr>
        <p:spPr>
          <a:xfrm flipH="1">
            <a:off x="8151120" y="5060880"/>
            <a:ext cx="3960" cy="134208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62" name="TextBox 22"/>
          <p:cNvSpPr/>
          <p:nvPr/>
        </p:nvSpPr>
        <p:spPr>
          <a:xfrm rot="16200000">
            <a:off x="7858440" y="4267440"/>
            <a:ext cx="1201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deletion in KO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23"/>
          <p:cNvSpPr/>
          <p:nvPr/>
        </p:nvSpPr>
        <p:spPr>
          <a:xfrm rot="16200000">
            <a:off x="7685640" y="5585400"/>
            <a:ext cx="1547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amplification in KO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Straight Connector 24"/>
          <p:cNvSpPr/>
          <p:nvPr/>
        </p:nvSpPr>
        <p:spPr>
          <a:xfrm>
            <a:off x="1295280" y="4994280"/>
            <a:ext cx="7315200" cy="0"/>
          </a:xfrm>
          <a:prstGeom prst="line">
            <a:avLst/>
          </a:prstGeom>
          <a:ln w="19080">
            <a:solidFill>
              <a:srgbClr val="4a7ebb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5" name="Straight Arrow Connector 25"/>
          <p:cNvCxnSpPr/>
          <p:nvPr/>
        </p:nvCxnSpPr>
        <p:spPr>
          <a:xfrm flipV="1">
            <a:off x="8150760" y="10997640"/>
            <a:ext cx="3960" cy="99108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66" name="Straight Arrow Connector 26"/>
          <p:cNvCxnSpPr/>
          <p:nvPr/>
        </p:nvCxnSpPr>
        <p:spPr>
          <a:xfrm flipH="1">
            <a:off x="8152560" y="12122280"/>
            <a:ext cx="2520" cy="134208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67" name="TextBox 27"/>
          <p:cNvSpPr/>
          <p:nvPr/>
        </p:nvSpPr>
        <p:spPr>
          <a:xfrm rot="16200000">
            <a:off x="7858440" y="11329200"/>
            <a:ext cx="1201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deletion in KO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28"/>
          <p:cNvSpPr/>
          <p:nvPr/>
        </p:nvSpPr>
        <p:spPr>
          <a:xfrm rot="16200000">
            <a:off x="7685640" y="12647520"/>
            <a:ext cx="1547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amplification in KO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Straight Connector 29"/>
          <p:cNvSpPr/>
          <p:nvPr/>
        </p:nvSpPr>
        <p:spPr>
          <a:xfrm>
            <a:off x="1295280" y="12055320"/>
            <a:ext cx="7315200" cy="0"/>
          </a:xfrm>
          <a:prstGeom prst="line">
            <a:avLst/>
          </a:prstGeom>
          <a:ln w="19080">
            <a:solidFill>
              <a:srgbClr val="4a7ebb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Straight Connector 30"/>
          <p:cNvSpPr/>
          <p:nvPr/>
        </p:nvSpPr>
        <p:spPr>
          <a:xfrm>
            <a:off x="3886200" y="8991720"/>
            <a:ext cx="0" cy="2133360"/>
          </a:xfrm>
          <a:prstGeom prst="line">
            <a:avLst/>
          </a:prstGeom>
          <a:ln w="2556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Straight Connector 31"/>
          <p:cNvSpPr/>
          <p:nvPr/>
        </p:nvSpPr>
        <p:spPr>
          <a:xfrm>
            <a:off x="7162920" y="8991720"/>
            <a:ext cx="0" cy="2133360"/>
          </a:xfrm>
          <a:prstGeom prst="line">
            <a:avLst/>
          </a:prstGeom>
          <a:ln w="2556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Straight Connector 32"/>
          <p:cNvSpPr/>
          <p:nvPr/>
        </p:nvSpPr>
        <p:spPr>
          <a:xfrm>
            <a:off x="5159520" y="8991720"/>
            <a:ext cx="0" cy="2133360"/>
          </a:xfrm>
          <a:prstGeom prst="line">
            <a:avLst/>
          </a:prstGeom>
          <a:ln w="2556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Straight Connector 33"/>
          <p:cNvSpPr/>
          <p:nvPr/>
        </p:nvSpPr>
        <p:spPr>
          <a:xfrm>
            <a:off x="5638680" y="8991720"/>
            <a:ext cx="0" cy="2133360"/>
          </a:xfrm>
          <a:prstGeom prst="line">
            <a:avLst/>
          </a:prstGeom>
          <a:ln w="25560">
            <a:solidFill>
              <a:srgbClr val="ff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Rectangle 34"/>
          <p:cNvSpPr/>
          <p:nvPr/>
        </p:nvSpPr>
        <p:spPr>
          <a:xfrm>
            <a:off x="4201200" y="8621640"/>
            <a:ext cx="67140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ECH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Rectangle 35"/>
          <p:cNvSpPr/>
          <p:nvPr/>
        </p:nvSpPr>
        <p:spPr>
          <a:xfrm>
            <a:off x="6099840" y="8621640"/>
            <a:ext cx="67140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ECH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37"/>
          <p:cNvSpPr/>
          <p:nvPr/>
        </p:nvSpPr>
        <p:spPr>
          <a:xfrm>
            <a:off x="457200" y="6988320"/>
            <a:ext cx="8686800" cy="398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B. Locus view.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7" name="Picture 3" descr=""/>
          <p:cNvPicPr/>
          <p:nvPr/>
        </p:nvPicPr>
        <p:blipFill>
          <a:blip r:embed="rId4"/>
          <a:srcRect l="18750" t="91880" r="5345" b="5000"/>
          <a:stretch/>
        </p:blipFill>
        <p:spPr>
          <a:xfrm>
            <a:off x="533520" y="13411080"/>
            <a:ext cx="7404120" cy="228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23T14:58:49Z</dcterms:created>
  <dc:creator> </dc:creator>
  <dc:description/>
  <dc:language>en-US</dc:language>
  <cp:lastModifiedBy>gall06</cp:lastModifiedBy>
  <dcterms:modified xsi:type="dcterms:W3CDTF">2011-01-13T14:27:43Z</dcterms:modified>
  <cp:revision>3</cp:revision>
  <dc:subject/>
  <dc:title>Slide 1</dc:title>
</cp:coreProperties>
</file>